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110" d="100"/>
          <a:sy n="110" d="100"/>
        </p:scale>
        <p:origin x="1378" y="-3269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46633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65551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82535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99316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768112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2027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15341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8577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29744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4948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6411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543BB7-B290-432F-ACE4-AF34919AEC46}" type="datetimeFigureOut">
              <a:rPr lang="en-IN" smtClean="0"/>
              <a:t>03-12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0339991-BA60-4FE1-85E0-50284FF16EEE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08848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72EA2C6-1D2A-7708-D034-C64F48258D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4402" y="635000"/>
            <a:ext cx="4469195" cy="7200000"/>
          </a:xfrm>
          <a:prstGeom prst="rect">
            <a:avLst/>
          </a:prstGeom>
        </p:spPr>
      </p:pic>
      <p:sp>
        <p:nvSpPr>
          <p:cNvPr id="4" name="TextBox 5">
            <a:extLst>
              <a:ext uri="{FF2B5EF4-FFF2-40B4-BE49-F238E27FC236}">
                <a16:creationId xmlns:a16="http://schemas.microsoft.com/office/drawing/2014/main" id="{2D5C9B66-E727-F12B-CF5C-E3AF7E80930C}"/>
              </a:ext>
            </a:extLst>
          </p:cNvPr>
          <p:cNvSpPr txBox="1"/>
          <p:nvPr/>
        </p:nvSpPr>
        <p:spPr>
          <a:xfrm>
            <a:off x="793173" y="8098818"/>
            <a:ext cx="55626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IN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4. </a:t>
            </a:r>
            <a:r>
              <a:rPr lang="en-IN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Comparison of amino acid sequences of LsTPS21. Deduced amino acid sequences from this study were aligned with that from Phytozome database.</a:t>
            </a:r>
            <a:endParaRPr lang="en-IN" sz="10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5782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</TotalTime>
  <Words>2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khileshwar Singh</dc:creator>
  <cp:lastModifiedBy>Sungbeom Lee</cp:lastModifiedBy>
  <cp:revision>5</cp:revision>
  <dcterms:created xsi:type="dcterms:W3CDTF">2025-11-12T01:35:52Z</dcterms:created>
  <dcterms:modified xsi:type="dcterms:W3CDTF">2025-12-03T03:36:09Z</dcterms:modified>
</cp:coreProperties>
</file>